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61" r:id="rId3"/>
    <p:sldId id="262" r:id="rId4"/>
    <p:sldId id="263" r:id="rId5"/>
    <p:sldId id="257" r:id="rId6"/>
    <p:sldId id="266" r:id="rId7"/>
    <p:sldId id="258" r:id="rId8"/>
    <p:sldId id="259" r:id="rId9"/>
    <p:sldId id="260" r:id="rId10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58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2442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wmf"/><Relationship Id="rId2" Type="http://schemas.openxmlformats.org/officeDocument/2006/relationships/image" Target="../media/image13.wmf"/><Relationship Id="rId1" Type="http://schemas.openxmlformats.org/officeDocument/2006/relationships/image" Target="../media/image12.wmf"/><Relationship Id="rId6" Type="http://schemas.openxmlformats.org/officeDocument/2006/relationships/image" Target="../media/image17.wmf"/><Relationship Id="rId5" Type="http://schemas.openxmlformats.org/officeDocument/2006/relationships/image" Target="../media/image16.wmf"/><Relationship Id="rId4" Type="http://schemas.openxmlformats.org/officeDocument/2006/relationships/image" Target="../media/image15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B32F4-48C0-4731-96A5-FD0D03425D46}" type="datetimeFigureOut">
              <a:rPr lang="ko-KR" altLang="en-US" smtClean="0"/>
              <a:t>2021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14505-7E8B-4584-AC0C-6B739642B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9505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B32F4-48C0-4731-96A5-FD0D03425D46}" type="datetimeFigureOut">
              <a:rPr lang="ko-KR" altLang="en-US" smtClean="0"/>
              <a:t>2021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14505-7E8B-4584-AC0C-6B739642B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7048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B32F4-48C0-4731-96A5-FD0D03425D46}" type="datetimeFigureOut">
              <a:rPr lang="ko-KR" altLang="en-US" smtClean="0"/>
              <a:t>2021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14505-7E8B-4584-AC0C-6B739642B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7843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B32F4-48C0-4731-96A5-FD0D03425D46}" type="datetimeFigureOut">
              <a:rPr lang="ko-KR" altLang="en-US" smtClean="0"/>
              <a:t>2021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14505-7E8B-4584-AC0C-6B739642B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52806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B32F4-48C0-4731-96A5-FD0D03425D46}" type="datetimeFigureOut">
              <a:rPr lang="ko-KR" altLang="en-US" smtClean="0"/>
              <a:t>2021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14505-7E8B-4584-AC0C-6B739642B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2858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B32F4-48C0-4731-96A5-FD0D03425D46}" type="datetimeFigureOut">
              <a:rPr lang="ko-KR" altLang="en-US" smtClean="0"/>
              <a:t>2021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14505-7E8B-4584-AC0C-6B739642B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3107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B32F4-48C0-4731-96A5-FD0D03425D46}" type="datetimeFigureOut">
              <a:rPr lang="ko-KR" altLang="en-US" smtClean="0"/>
              <a:t>2021-12-2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14505-7E8B-4584-AC0C-6B739642B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0436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B32F4-48C0-4731-96A5-FD0D03425D46}" type="datetimeFigureOut">
              <a:rPr lang="ko-KR" altLang="en-US" smtClean="0"/>
              <a:t>2021-12-2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14505-7E8B-4584-AC0C-6B739642B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3291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B32F4-48C0-4731-96A5-FD0D03425D46}" type="datetimeFigureOut">
              <a:rPr lang="ko-KR" altLang="en-US" smtClean="0"/>
              <a:t>2021-12-2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14505-7E8B-4584-AC0C-6B739642B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4886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B32F4-48C0-4731-96A5-FD0D03425D46}" type="datetimeFigureOut">
              <a:rPr lang="ko-KR" altLang="en-US" smtClean="0"/>
              <a:t>2021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14505-7E8B-4584-AC0C-6B739642B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191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B32F4-48C0-4731-96A5-FD0D03425D46}" type="datetimeFigureOut">
              <a:rPr lang="ko-KR" altLang="en-US" smtClean="0"/>
              <a:t>2021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14505-7E8B-4584-AC0C-6B739642B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3220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8B32F4-48C0-4731-96A5-FD0D03425D46}" type="datetimeFigureOut">
              <a:rPr lang="ko-KR" altLang="en-US" smtClean="0"/>
              <a:t>2021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314505-7E8B-4584-AC0C-6B739642B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2472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wmf"/><Relationship Id="rId13" Type="http://schemas.openxmlformats.org/officeDocument/2006/relationships/oleObject" Target="../embeddings/oleObject12.bin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12" Type="http://schemas.openxmlformats.org/officeDocument/2006/relationships/image" Target="../media/image16.w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3.wmf"/><Relationship Id="rId11" Type="http://schemas.openxmlformats.org/officeDocument/2006/relationships/oleObject" Target="../embeddings/oleObject11.bin"/><Relationship Id="rId5" Type="http://schemas.openxmlformats.org/officeDocument/2006/relationships/oleObject" Target="../embeddings/oleObject8.bin"/><Relationship Id="rId10" Type="http://schemas.openxmlformats.org/officeDocument/2006/relationships/image" Target="../media/image15.wmf"/><Relationship Id="rId4" Type="http://schemas.openxmlformats.org/officeDocument/2006/relationships/image" Target="../media/image12.wmf"/><Relationship Id="rId9" Type="http://schemas.openxmlformats.org/officeDocument/2006/relationships/oleObject" Target="../embeddings/oleObject10.bin"/><Relationship Id="rId14" Type="http://schemas.openxmlformats.org/officeDocument/2006/relationships/image" Target="../media/image17.w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3938853" y="125784"/>
            <a:ext cx="2751074" cy="307777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7D(raw data). </a:t>
            </a:r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Kim et al.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66"/>
          <p:cNvSpPr txBox="1">
            <a:spLocks noChangeArrowheads="1"/>
          </p:cNvSpPr>
          <p:nvPr/>
        </p:nvSpPr>
        <p:spPr bwMode="auto">
          <a:xfrm>
            <a:off x="444627" y="761691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eaLnBrk="1" hangingPunct="1"/>
            <a:r>
              <a:rPr kumimoji="0" lang="en-US" altLang="ko-KR" sz="1400" b="1" dirty="0" smtClean="0">
                <a:latin typeface="Arial" charset="0"/>
                <a:ea typeface="맑은 고딕" pitchFamily="50" charset="-127"/>
                <a:cs typeface="Arial" charset="0"/>
              </a:rPr>
              <a:t>D</a:t>
            </a:r>
            <a:endParaRPr kumimoji="0" lang="ko-KR" altLang="en-US" sz="1400" b="1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grpSp>
        <p:nvGrpSpPr>
          <p:cNvPr id="22" name="그룹 21"/>
          <p:cNvGrpSpPr/>
          <p:nvPr/>
        </p:nvGrpSpPr>
        <p:grpSpPr>
          <a:xfrm>
            <a:off x="1155310" y="724221"/>
            <a:ext cx="4195261" cy="705799"/>
            <a:chOff x="1155310" y="724221"/>
            <a:chExt cx="4195261" cy="705799"/>
          </a:xfrm>
        </p:grpSpPr>
        <p:sp>
          <p:nvSpPr>
            <p:cNvPr id="67" name="직사각형 66"/>
            <p:cNvSpPr>
              <a:spLocks noChangeArrowheads="1"/>
            </p:cNvSpPr>
            <p:nvPr/>
          </p:nvSpPr>
          <p:spPr bwMode="auto">
            <a:xfrm>
              <a:off x="2284416" y="725997"/>
              <a:ext cx="48923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charset="0"/>
                  <a:ea typeface="맑은 고딕" pitchFamily="50" charset="-127"/>
                  <a:cs typeface="Arial" charset="0"/>
                </a:rPr>
                <a:t>A549</a:t>
              </a:r>
              <a:endParaRPr lang="en-US" altLang="ko-KR" sz="1000" b="1" dirty="0">
                <a:latin typeface="Arial" charset="0"/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68" name="직사각형 67"/>
            <p:cNvSpPr>
              <a:spLocks noChangeArrowheads="1"/>
            </p:cNvSpPr>
            <p:nvPr/>
          </p:nvSpPr>
          <p:spPr bwMode="auto">
            <a:xfrm>
              <a:off x="3392103" y="724221"/>
              <a:ext cx="55976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charset="0"/>
                  <a:ea typeface="맑은 고딕" pitchFamily="50" charset="-127"/>
                  <a:cs typeface="Arial" charset="0"/>
                </a:rPr>
                <a:t>H1299</a:t>
              </a:r>
              <a:endParaRPr lang="en-US" altLang="ko-KR" sz="1000" b="1" dirty="0">
                <a:latin typeface="Arial" charset="0"/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69" name="직사각형 68"/>
            <p:cNvSpPr>
              <a:spLocks noChangeArrowheads="1"/>
            </p:cNvSpPr>
            <p:nvPr/>
          </p:nvSpPr>
          <p:spPr bwMode="auto">
            <a:xfrm>
              <a:off x="4473304" y="724706"/>
              <a:ext cx="66075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charset="0"/>
                  <a:ea typeface="맑은 고딕" pitchFamily="50" charset="-127"/>
                  <a:cs typeface="Arial" charset="0"/>
                </a:rPr>
                <a:t>SKOV-3</a:t>
              </a:r>
              <a:endParaRPr lang="en-US" altLang="ko-KR" sz="1000" b="1" dirty="0">
                <a:latin typeface="Arial" charset="0"/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73" name="TextBox 72"/>
            <p:cNvSpPr txBox="1">
              <a:spLocks noChangeArrowheads="1"/>
            </p:cNvSpPr>
            <p:nvPr/>
          </p:nvSpPr>
          <p:spPr bwMode="auto">
            <a:xfrm>
              <a:off x="1155310" y="945712"/>
              <a:ext cx="86573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charset="0"/>
                  <a:ea typeface="맑은 고딕" pitchFamily="50" charset="-127"/>
                  <a:cs typeface="Arial" charset="0"/>
                </a:rPr>
                <a:t>Integrin </a:t>
              </a:r>
              <a:r>
                <a:rPr lang="en-US" altLang="ko-KR" sz="1000" b="1" dirty="0" smtClean="0">
                  <a:latin typeface="Symbol" panose="05050102010706020507" pitchFamily="18" charset="2"/>
                  <a:ea typeface="맑은 고딕" pitchFamily="50" charset="-127"/>
                  <a:cs typeface="Arial" charset="0"/>
                </a:rPr>
                <a:t>b</a:t>
              </a:r>
              <a:r>
                <a:rPr lang="en-US" altLang="ko-KR" sz="1000" b="1" dirty="0" smtClean="0">
                  <a:latin typeface="Arial" charset="0"/>
                  <a:ea typeface="맑은 고딕" pitchFamily="50" charset="-127"/>
                  <a:cs typeface="Arial" charset="0"/>
                </a:rPr>
                <a:t>1</a:t>
              </a:r>
              <a:endParaRPr lang="ko-KR" altLang="en-US" sz="1000" b="1" dirty="0">
                <a:latin typeface="Arial" charset="0"/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74" name="TextBox 73"/>
            <p:cNvSpPr txBox="1">
              <a:spLocks noChangeArrowheads="1"/>
            </p:cNvSpPr>
            <p:nvPr/>
          </p:nvSpPr>
          <p:spPr bwMode="auto">
            <a:xfrm>
              <a:off x="1338689" y="1183799"/>
              <a:ext cx="67792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charset="0"/>
                  <a:ea typeface="맑은 고딕" pitchFamily="50" charset="-127"/>
                  <a:cs typeface="Arial" charset="0"/>
                </a:rPr>
                <a:t>GAPDH</a:t>
              </a:r>
              <a:endParaRPr lang="ko-KR" altLang="en-US" sz="1000" b="1" dirty="0">
                <a:latin typeface="Arial" charset="0"/>
                <a:ea typeface="맑은 고딕" pitchFamily="50" charset="-127"/>
                <a:cs typeface="Arial" charset="0"/>
              </a:endParaRPr>
            </a:p>
          </p:txBody>
        </p:sp>
        <p:graphicFrame>
          <p:nvGraphicFramePr>
            <p:cNvPr id="16" name="개체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44609130"/>
                </p:ext>
              </p:extLst>
            </p:nvPr>
          </p:nvGraphicFramePr>
          <p:xfrm>
            <a:off x="3133583" y="1220044"/>
            <a:ext cx="1080000" cy="1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5" name="Image" r:id="rId3" imgW="885240" imgH="144720" progId="Photoshop.Image.12">
                    <p:embed/>
                  </p:oleObj>
                </mc:Choice>
                <mc:Fallback>
                  <p:oleObj name="Image" r:id="rId3" imgW="885240" imgH="144720" progId="Photoshop.Image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133583" y="1220044"/>
                          <a:ext cx="1080000" cy="18000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" name="개체 1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09643285"/>
                </p:ext>
              </p:extLst>
            </p:nvPr>
          </p:nvGraphicFramePr>
          <p:xfrm>
            <a:off x="4270571" y="1217674"/>
            <a:ext cx="1080000" cy="1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6" name="Image" r:id="rId5" imgW="885240" imgH="138600" progId="Photoshop.Image.12">
                    <p:embed/>
                  </p:oleObj>
                </mc:Choice>
                <mc:Fallback>
                  <p:oleObj name="Image" r:id="rId5" imgW="885240" imgH="138600" progId="Photoshop.Image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270571" y="1217674"/>
                          <a:ext cx="1080000" cy="18000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" name="개체 1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74794216"/>
                </p:ext>
              </p:extLst>
            </p:nvPr>
          </p:nvGraphicFramePr>
          <p:xfrm>
            <a:off x="1996594" y="1220044"/>
            <a:ext cx="1080000" cy="1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7" name="Image" r:id="rId7" imgW="897480" imgH="138600" progId="Photoshop.Image.12">
                    <p:embed/>
                  </p:oleObj>
                </mc:Choice>
                <mc:Fallback>
                  <p:oleObj name="Image" r:id="rId7" imgW="897480" imgH="138600" progId="Photoshop.Image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996594" y="1220044"/>
                          <a:ext cx="1080000" cy="18000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개체 1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06702576"/>
                </p:ext>
              </p:extLst>
            </p:nvPr>
          </p:nvGraphicFramePr>
          <p:xfrm>
            <a:off x="3133204" y="988646"/>
            <a:ext cx="1080000" cy="1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8" name="Image" r:id="rId9" imgW="1695960" imgH="255960" progId="Photoshop.Image.12">
                    <p:embed/>
                  </p:oleObj>
                </mc:Choice>
                <mc:Fallback>
                  <p:oleObj name="Image" r:id="rId9" imgW="1695960" imgH="255960" progId="Photoshop.Image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133204" y="988646"/>
                          <a:ext cx="1080000" cy="18000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개체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83467532"/>
                </p:ext>
              </p:extLst>
            </p:nvPr>
          </p:nvGraphicFramePr>
          <p:xfrm>
            <a:off x="4270571" y="987974"/>
            <a:ext cx="1080000" cy="1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9" name="Image" r:id="rId11" imgW="1184040" imgH="168840" progId="Photoshop.Image.12">
                    <p:embed/>
                  </p:oleObj>
                </mc:Choice>
                <mc:Fallback>
                  <p:oleObj name="Image" r:id="rId11" imgW="1184040" imgH="168840" progId="Photoshop.Image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4270571" y="987974"/>
                          <a:ext cx="1080000" cy="18000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" name="개체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00587271"/>
                </p:ext>
              </p:extLst>
            </p:nvPr>
          </p:nvGraphicFramePr>
          <p:xfrm>
            <a:off x="1995836" y="987804"/>
            <a:ext cx="1080000" cy="1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20" name="Image" r:id="rId13" imgW="996480" imgH="194760" progId="Photoshop.Image.12">
                    <p:embed/>
                  </p:oleObj>
                </mc:Choice>
                <mc:Fallback>
                  <p:oleObj name="Image" r:id="rId13" imgW="996480" imgH="194760" progId="Photoshop.Image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995836" y="987804"/>
                          <a:ext cx="1080000" cy="18000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7624173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3887" y="449506"/>
            <a:ext cx="5610225" cy="3743325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9162" y="4582917"/>
            <a:ext cx="5019675" cy="374332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269443" y="1329129"/>
            <a:ext cx="1266524" cy="299405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TextBox 6"/>
          <p:cNvSpPr txBox="1"/>
          <p:nvPr/>
        </p:nvSpPr>
        <p:spPr>
          <a:xfrm>
            <a:off x="4629067" y="1008114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ko-KR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321935" y="1265944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grin </a:t>
            </a:r>
            <a:r>
              <a:rPr lang="en-US" altLang="ko-KR" sz="12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965939" y="5425552"/>
            <a:ext cx="1266524" cy="299405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TextBox 12"/>
          <p:cNvSpPr txBox="1"/>
          <p:nvPr/>
        </p:nvSpPr>
        <p:spPr>
          <a:xfrm>
            <a:off x="1332287" y="5093779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ko-KR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44353" y="5432291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45328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7255" y="830109"/>
            <a:ext cx="4657725" cy="3495675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6279" y="4830695"/>
            <a:ext cx="5019675" cy="3743325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1188159" y="1693351"/>
            <a:ext cx="1124735" cy="299405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TextBox 5"/>
          <p:cNvSpPr txBox="1"/>
          <p:nvPr/>
        </p:nvSpPr>
        <p:spPr>
          <a:xfrm>
            <a:off x="1447891" y="1361578"/>
            <a:ext cx="635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ko-KR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37473" y="1703932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tegrin </a:t>
            </a:r>
            <a:r>
              <a:rPr lang="en-US" altLang="ko-KR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1447891" y="6036687"/>
            <a:ext cx="1124602" cy="299405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TextBox 8"/>
          <p:cNvSpPr txBox="1"/>
          <p:nvPr/>
        </p:nvSpPr>
        <p:spPr>
          <a:xfrm>
            <a:off x="1686102" y="5704914"/>
            <a:ext cx="635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ko-KR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34467" y="6043426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84564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9162" y="5083614"/>
            <a:ext cx="5019675" cy="3743325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8587" y="1284051"/>
            <a:ext cx="6600825" cy="36576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2094871" y="2162075"/>
            <a:ext cx="1401364" cy="299405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" name="TextBox 4"/>
          <p:cNvSpPr txBox="1"/>
          <p:nvPr/>
        </p:nvSpPr>
        <p:spPr>
          <a:xfrm>
            <a:off x="2454495" y="1837986"/>
            <a:ext cx="740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OV-3</a:t>
            </a:r>
            <a:endParaRPr lang="ko-KR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124311" y="2172656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grin </a:t>
            </a:r>
            <a:r>
              <a:rPr lang="en-US" altLang="ko-KR" sz="12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479071" y="6288383"/>
            <a:ext cx="1100083" cy="299405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TextBox 7"/>
          <p:cNvSpPr txBox="1"/>
          <p:nvPr/>
        </p:nvSpPr>
        <p:spPr>
          <a:xfrm>
            <a:off x="2646595" y="5956610"/>
            <a:ext cx="740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OV-3</a:t>
            </a:r>
            <a:endParaRPr lang="ko-KR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45261" y="6291280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31509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66"/>
          <p:cNvSpPr txBox="1">
            <a:spLocks noChangeArrowheads="1"/>
          </p:cNvSpPr>
          <p:nvPr/>
        </p:nvSpPr>
        <p:spPr bwMode="auto">
          <a:xfrm>
            <a:off x="451371" y="760343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eaLnBrk="1" hangingPunct="1"/>
            <a:r>
              <a:rPr kumimoji="0" lang="en-US" altLang="ko-KR" sz="1400" b="1" dirty="0" smtClean="0">
                <a:latin typeface="Arial" charset="0"/>
                <a:ea typeface="맑은 고딕" pitchFamily="50" charset="-127"/>
                <a:cs typeface="Arial" charset="0"/>
              </a:rPr>
              <a:t>E</a:t>
            </a:r>
            <a:endParaRPr kumimoji="0" lang="ko-KR" altLang="en-US" sz="1400" b="1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938853" y="125784"/>
            <a:ext cx="2751074" cy="307777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7E(raw data). </a:t>
            </a:r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Kim et al.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" name="그룹 8"/>
          <p:cNvGrpSpPr/>
          <p:nvPr/>
        </p:nvGrpSpPr>
        <p:grpSpPr>
          <a:xfrm>
            <a:off x="1152581" y="720836"/>
            <a:ext cx="4202125" cy="715363"/>
            <a:chOff x="1152581" y="720836"/>
            <a:chExt cx="4202125" cy="715363"/>
          </a:xfrm>
        </p:grpSpPr>
        <p:sp>
          <p:nvSpPr>
            <p:cNvPr id="11" name="직사각형 10"/>
            <p:cNvSpPr>
              <a:spLocks noChangeArrowheads="1"/>
            </p:cNvSpPr>
            <p:nvPr/>
          </p:nvSpPr>
          <p:spPr bwMode="auto">
            <a:xfrm>
              <a:off x="2286511" y="722612"/>
              <a:ext cx="48923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charset="0"/>
                  <a:ea typeface="맑은 고딕" pitchFamily="50" charset="-127"/>
                  <a:cs typeface="Arial" charset="0"/>
                </a:rPr>
                <a:t>A549</a:t>
              </a:r>
              <a:endParaRPr lang="en-US" altLang="ko-KR" sz="1000" b="1" dirty="0">
                <a:latin typeface="Arial" charset="0"/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12" name="직사각형 11"/>
            <p:cNvSpPr>
              <a:spLocks noChangeArrowheads="1"/>
            </p:cNvSpPr>
            <p:nvPr/>
          </p:nvSpPr>
          <p:spPr bwMode="auto">
            <a:xfrm>
              <a:off x="3394055" y="720836"/>
              <a:ext cx="55976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charset="0"/>
                  <a:ea typeface="맑은 고딕" pitchFamily="50" charset="-127"/>
                  <a:cs typeface="Arial" charset="0"/>
                </a:rPr>
                <a:t>H1299</a:t>
              </a:r>
              <a:endParaRPr lang="en-US" altLang="ko-KR" sz="1000" b="1" dirty="0">
                <a:latin typeface="Arial" charset="0"/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13" name="직사각형 12"/>
            <p:cNvSpPr>
              <a:spLocks noChangeArrowheads="1"/>
            </p:cNvSpPr>
            <p:nvPr/>
          </p:nvSpPr>
          <p:spPr bwMode="auto">
            <a:xfrm>
              <a:off x="4476964" y="721321"/>
              <a:ext cx="66075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charset="0"/>
                  <a:ea typeface="맑은 고딕" pitchFamily="50" charset="-127"/>
                  <a:cs typeface="Arial" charset="0"/>
                </a:rPr>
                <a:t>SKOV-3</a:t>
              </a:r>
              <a:endParaRPr lang="en-US" altLang="ko-KR" sz="1000" b="1" dirty="0">
                <a:latin typeface="Arial" charset="0"/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17" name="TextBox 16"/>
            <p:cNvSpPr txBox="1">
              <a:spLocks noChangeArrowheads="1"/>
            </p:cNvSpPr>
            <p:nvPr/>
          </p:nvSpPr>
          <p:spPr bwMode="auto">
            <a:xfrm>
              <a:off x="1152581" y="938575"/>
              <a:ext cx="86573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charset="0"/>
                  <a:ea typeface="맑은 고딕" pitchFamily="50" charset="-127"/>
                  <a:cs typeface="Arial" charset="0"/>
                </a:rPr>
                <a:t>Integrin </a:t>
              </a:r>
              <a:r>
                <a:rPr lang="en-US" altLang="ko-KR" sz="1000" b="1" dirty="0" smtClean="0">
                  <a:latin typeface="Symbol" panose="05050102010706020507" pitchFamily="18" charset="2"/>
                  <a:ea typeface="맑은 고딕" pitchFamily="50" charset="-127"/>
                  <a:cs typeface="Arial" charset="0"/>
                </a:rPr>
                <a:t>b</a:t>
              </a:r>
              <a:r>
                <a:rPr lang="en-US" altLang="ko-KR" sz="1000" b="1" dirty="0" smtClean="0">
                  <a:latin typeface="Arial" charset="0"/>
                  <a:ea typeface="맑은 고딕" pitchFamily="50" charset="-127"/>
                  <a:cs typeface="Arial" charset="0"/>
                </a:rPr>
                <a:t>1</a:t>
              </a:r>
              <a:endParaRPr lang="ko-KR" altLang="en-US" sz="1000" b="1" dirty="0">
                <a:latin typeface="Arial" charset="0"/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18" name="TextBox 17"/>
            <p:cNvSpPr txBox="1">
              <a:spLocks noChangeArrowheads="1"/>
            </p:cNvSpPr>
            <p:nvPr/>
          </p:nvSpPr>
          <p:spPr bwMode="auto">
            <a:xfrm>
              <a:off x="1342180" y="1189978"/>
              <a:ext cx="67792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charset="0"/>
                  <a:ea typeface="맑은 고딕" pitchFamily="50" charset="-127"/>
                  <a:cs typeface="Arial" charset="0"/>
                </a:rPr>
                <a:t>Actin</a:t>
              </a:r>
              <a:endParaRPr lang="ko-KR" altLang="en-US" sz="1000" b="1" dirty="0">
                <a:latin typeface="Arial" charset="0"/>
                <a:ea typeface="맑은 고딕" pitchFamily="50" charset="-127"/>
                <a:cs typeface="Arial" charset="0"/>
              </a:endParaRPr>
            </a:p>
          </p:txBody>
        </p:sp>
        <p:graphicFrame>
          <p:nvGraphicFramePr>
            <p:cNvPr id="2" name="개체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4118879"/>
                </p:ext>
              </p:extLst>
            </p:nvPr>
          </p:nvGraphicFramePr>
          <p:xfrm>
            <a:off x="3133993" y="977771"/>
            <a:ext cx="1080000" cy="1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21" name="Image" r:id="rId3" imgW="6837840" imgH="1285560" progId="Photoshop.Image.12">
                    <p:embed/>
                  </p:oleObj>
                </mc:Choice>
                <mc:Fallback>
                  <p:oleObj name="Image" r:id="rId3" imgW="6837840" imgH="1285560" progId="Photoshop.Image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133993" y="977771"/>
                          <a:ext cx="1080000" cy="18000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개체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02977567"/>
                </p:ext>
              </p:extLst>
            </p:nvPr>
          </p:nvGraphicFramePr>
          <p:xfrm>
            <a:off x="1995739" y="1226150"/>
            <a:ext cx="1080000" cy="1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22" name="Image" r:id="rId5" imgW="7009200" imgH="1180800" progId="Photoshop.Image.12">
                    <p:embed/>
                  </p:oleObj>
                </mc:Choice>
                <mc:Fallback>
                  <p:oleObj name="Image" r:id="rId5" imgW="7009200" imgH="1180800" progId="Photoshop.Image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995739" y="1226150"/>
                          <a:ext cx="1080000" cy="18000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개체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16337888"/>
                </p:ext>
              </p:extLst>
            </p:nvPr>
          </p:nvGraphicFramePr>
          <p:xfrm>
            <a:off x="3135128" y="1227114"/>
            <a:ext cx="1080000" cy="1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23" name="Image" r:id="rId7" imgW="6914160" imgH="1228320" progId="Photoshop.Image.12">
                    <p:embed/>
                  </p:oleObj>
                </mc:Choice>
                <mc:Fallback>
                  <p:oleObj name="Image" r:id="rId7" imgW="6914160" imgH="1228320" progId="Photoshop.Image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135128" y="1227114"/>
                          <a:ext cx="1080000" cy="18000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개체 2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52173599"/>
                </p:ext>
              </p:extLst>
            </p:nvPr>
          </p:nvGraphicFramePr>
          <p:xfrm>
            <a:off x="4274706" y="1226853"/>
            <a:ext cx="1080000" cy="1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24" name="Image" r:id="rId9" imgW="6837840" imgH="1180800" progId="Photoshop.Image.12">
                    <p:embed/>
                  </p:oleObj>
                </mc:Choice>
                <mc:Fallback>
                  <p:oleObj name="Image" r:id="rId9" imgW="6837840" imgH="1180800" progId="Photoshop.Image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274706" y="1226853"/>
                          <a:ext cx="1080000" cy="18000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개체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5957919"/>
                </p:ext>
              </p:extLst>
            </p:nvPr>
          </p:nvGraphicFramePr>
          <p:xfrm>
            <a:off x="4273921" y="977110"/>
            <a:ext cx="1080000" cy="1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25" name="Image" r:id="rId11" imgW="7200000" imgH="1152360" progId="Photoshop.Image.12">
                    <p:embed/>
                  </p:oleObj>
                </mc:Choice>
                <mc:Fallback>
                  <p:oleObj name="Image" r:id="rId11" imgW="7200000" imgH="1152360" progId="Photoshop.Image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4273921" y="977110"/>
                          <a:ext cx="1080000" cy="18000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개체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19641852"/>
                </p:ext>
              </p:extLst>
            </p:nvPr>
          </p:nvGraphicFramePr>
          <p:xfrm>
            <a:off x="1998593" y="978980"/>
            <a:ext cx="1080000" cy="1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26" name="Image" r:id="rId13" imgW="7295040" imgH="1228320" progId="Photoshop.Image.12">
                    <p:embed/>
                  </p:oleObj>
                </mc:Choice>
                <mc:Fallback>
                  <p:oleObj name="Image" r:id="rId13" imgW="7295040" imgH="1228320" progId="Photoshop.Image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998593" y="978980"/>
                          <a:ext cx="1080000" cy="18000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2240730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6463" y="4722354"/>
            <a:ext cx="3886200" cy="3876675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93991" y="691002"/>
            <a:ext cx="3886200" cy="3876675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3851809" y="1165074"/>
            <a:ext cx="1455554" cy="299405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TextBox 5"/>
          <p:cNvSpPr txBox="1"/>
          <p:nvPr/>
        </p:nvSpPr>
        <p:spPr>
          <a:xfrm>
            <a:off x="4313055" y="833301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ko-KR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933307" y="1171817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grin </a:t>
            </a:r>
            <a:r>
              <a:rPr lang="en-US" altLang="ko-KR" sz="12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938853" y="125784"/>
            <a:ext cx="2751074" cy="307777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7E(raw data). </a:t>
            </a:r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Kim et al.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53154" y="8634198"/>
            <a:ext cx="5262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Box indicates the portion used in the figures.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직사각형 23"/>
          <p:cNvSpPr/>
          <p:nvPr/>
        </p:nvSpPr>
        <p:spPr>
          <a:xfrm>
            <a:off x="3856285" y="5190239"/>
            <a:ext cx="1455554" cy="29940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317531" y="4858466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937783" y="5196982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tegrin </a:t>
            </a:r>
            <a:r>
              <a:rPr lang="en-US" altLang="ko-KR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345167" y="8190550"/>
            <a:ext cx="21836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ackground reversal figur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02167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그룹 14"/>
          <p:cNvGrpSpPr/>
          <p:nvPr/>
        </p:nvGrpSpPr>
        <p:grpSpPr>
          <a:xfrm>
            <a:off x="1498754" y="725383"/>
            <a:ext cx="3876675" cy="3857625"/>
            <a:chOff x="1498754" y="976235"/>
            <a:chExt cx="3876675" cy="3857625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98754" y="976235"/>
              <a:ext cx="3876675" cy="3857625"/>
            </a:xfrm>
            <a:prstGeom prst="rect">
              <a:avLst/>
            </a:prstGeom>
          </p:spPr>
        </p:pic>
        <p:sp>
          <p:nvSpPr>
            <p:cNvPr id="6" name="직사각형 5"/>
            <p:cNvSpPr/>
            <p:nvPr/>
          </p:nvSpPr>
          <p:spPr>
            <a:xfrm>
              <a:off x="3584773" y="2775561"/>
              <a:ext cx="1455554" cy="299405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981283" y="2443788"/>
              <a:ext cx="6351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299</a:t>
              </a:r>
              <a:endParaRPr lang="ko-KR" alt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677029" y="2790396"/>
              <a:ext cx="9092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tegrin </a:t>
              </a:r>
              <a:r>
                <a:rPr lang="en-US" altLang="ko-KR" sz="1200" dirty="0" smtClean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US" altLang="ko-KR" sz="12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그룹 13"/>
          <p:cNvGrpSpPr/>
          <p:nvPr/>
        </p:nvGrpSpPr>
        <p:grpSpPr>
          <a:xfrm>
            <a:off x="1493992" y="4721398"/>
            <a:ext cx="3886200" cy="3876675"/>
            <a:chOff x="1493992" y="4891330"/>
            <a:chExt cx="3886200" cy="387667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93992" y="4891330"/>
              <a:ext cx="3886200" cy="3876675"/>
            </a:xfrm>
            <a:prstGeom prst="rect">
              <a:avLst/>
            </a:prstGeom>
          </p:spPr>
        </p:pic>
        <p:sp>
          <p:nvSpPr>
            <p:cNvPr id="9" name="직사각형 8"/>
            <p:cNvSpPr/>
            <p:nvPr/>
          </p:nvSpPr>
          <p:spPr>
            <a:xfrm>
              <a:off x="3567241" y="6658373"/>
              <a:ext cx="1455554" cy="2994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963751" y="6326600"/>
              <a:ext cx="6351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1299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670255" y="6673208"/>
              <a:ext cx="9092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tegrin </a:t>
              </a:r>
              <a:r>
                <a:rPr lang="en-US" altLang="ko-KR" sz="1200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3938853" y="125784"/>
            <a:ext cx="2751074" cy="307777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7E(raw data). </a:t>
            </a:r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Kim et al.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53154" y="8634198"/>
            <a:ext cx="5262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Box indicates the portion used in the figures.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345167" y="8190550"/>
            <a:ext cx="21836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ackground reversal figur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24070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5908" y="734077"/>
            <a:ext cx="3886200" cy="3838575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3938853" y="125784"/>
            <a:ext cx="2751074" cy="307777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7E(raw data). </a:t>
            </a:r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Kim et al.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53154" y="8634198"/>
            <a:ext cx="5262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Box indicates the portion used in the figures.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/>
          <p:cNvSpPr/>
          <p:nvPr/>
        </p:nvSpPr>
        <p:spPr>
          <a:xfrm>
            <a:off x="3604945" y="1657365"/>
            <a:ext cx="1455554" cy="299405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/>
          <p:cNvSpPr txBox="1"/>
          <p:nvPr/>
        </p:nvSpPr>
        <p:spPr>
          <a:xfrm>
            <a:off x="4001455" y="1325592"/>
            <a:ext cx="740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OV-3</a:t>
            </a:r>
            <a:endParaRPr lang="ko-KR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697201" y="1672200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grin </a:t>
            </a:r>
            <a:r>
              <a:rPr lang="en-US" altLang="ko-KR" sz="12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91303" y="4721746"/>
            <a:ext cx="3876675" cy="3867150"/>
          </a:xfrm>
          <a:prstGeom prst="rect">
            <a:avLst/>
          </a:prstGeom>
        </p:spPr>
      </p:pic>
      <p:sp>
        <p:nvSpPr>
          <p:cNvPr id="24" name="직사각형 23"/>
          <p:cNvSpPr/>
          <p:nvPr/>
        </p:nvSpPr>
        <p:spPr>
          <a:xfrm>
            <a:off x="3609425" y="5669085"/>
            <a:ext cx="1455554" cy="29940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005935" y="5337312"/>
            <a:ext cx="740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KOV-3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701681" y="5683920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tegrin </a:t>
            </a:r>
            <a:r>
              <a:rPr lang="en-US" altLang="ko-KR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345167" y="8190550"/>
            <a:ext cx="21836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ackground reversal figur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32699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3938853" y="125784"/>
            <a:ext cx="2751074" cy="307777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7E(raw data). </a:t>
            </a:r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Kim et al.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53154" y="8634198"/>
            <a:ext cx="5391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Boxes indicate the portions used in the figures.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1503517" y="682057"/>
            <a:ext cx="3867150" cy="3895725"/>
            <a:chOff x="1503517" y="682057"/>
            <a:chExt cx="3867150" cy="3895725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03517" y="682057"/>
              <a:ext cx="3867150" cy="3895725"/>
            </a:xfrm>
            <a:prstGeom prst="rect">
              <a:avLst/>
            </a:prstGeom>
          </p:spPr>
        </p:pic>
        <p:sp>
          <p:nvSpPr>
            <p:cNvPr id="6" name="직사각형 5"/>
            <p:cNvSpPr/>
            <p:nvPr/>
          </p:nvSpPr>
          <p:spPr>
            <a:xfrm>
              <a:off x="2321467" y="2338593"/>
              <a:ext cx="1383680" cy="299405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716441" y="2006820"/>
              <a:ext cx="6351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299</a:t>
              </a:r>
              <a:endParaRPr lang="ko-KR" alt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770725" y="2353428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ko-KR" alt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직사각형 11"/>
            <p:cNvSpPr/>
            <p:nvPr/>
          </p:nvSpPr>
          <p:spPr>
            <a:xfrm>
              <a:off x="3703851" y="2337245"/>
              <a:ext cx="1383680" cy="299405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981595" y="2005472"/>
              <a:ext cx="740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KOV-3</a:t>
              </a:r>
              <a:endParaRPr lang="ko-KR" alt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직사각형 22"/>
            <p:cNvSpPr/>
            <p:nvPr/>
          </p:nvSpPr>
          <p:spPr>
            <a:xfrm>
              <a:off x="2708327" y="1084225"/>
              <a:ext cx="1383680" cy="299405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138470" y="752452"/>
              <a:ext cx="5421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  <a:endParaRPr lang="ko-KR" alt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157585" y="1099060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ko-KR" alt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그룹 4"/>
          <p:cNvGrpSpPr/>
          <p:nvPr/>
        </p:nvGrpSpPr>
        <p:grpSpPr>
          <a:xfrm>
            <a:off x="1493992" y="4719965"/>
            <a:ext cx="3886200" cy="3895725"/>
            <a:chOff x="1493992" y="4719965"/>
            <a:chExt cx="3886200" cy="3895725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93992" y="4719965"/>
              <a:ext cx="3886200" cy="3895725"/>
            </a:xfrm>
            <a:prstGeom prst="rect">
              <a:avLst/>
            </a:prstGeom>
          </p:spPr>
        </p:pic>
        <p:sp>
          <p:nvSpPr>
            <p:cNvPr id="26" name="직사각형 25"/>
            <p:cNvSpPr/>
            <p:nvPr/>
          </p:nvSpPr>
          <p:spPr>
            <a:xfrm>
              <a:off x="2321468" y="6363729"/>
              <a:ext cx="1383680" cy="2994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716442" y="6031956"/>
              <a:ext cx="6351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1299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770726" y="6378564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직사각형 28"/>
            <p:cNvSpPr/>
            <p:nvPr/>
          </p:nvSpPr>
          <p:spPr>
            <a:xfrm>
              <a:off x="3703852" y="6362381"/>
              <a:ext cx="1383680" cy="2994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981596" y="6030608"/>
              <a:ext cx="740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KOV-3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직사각형 30"/>
            <p:cNvSpPr/>
            <p:nvPr/>
          </p:nvSpPr>
          <p:spPr>
            <a:xfrm>
              <a:off x="2708328" y="5109361"/>
              <a:ext cx="1383680" cy="2994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138471" y="4777588"/>
              <a:ext cx="5421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157586" y="5124196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2345167" y="8190550"/>
            <a:ext cx="21836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ackground reversal figur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76482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9</TotalTime>
  <Words>153</Words>
  <Application>Microsoft Office PowerPoint</Application>
  <PresentationFormat>화면 슬라이드 쇼(4:3)</PresentationFormat>
  <Paragraphs>60</Paragraphs>
  <Slides>9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6" baseType="lpstr">
      <vt:lpstr>맑은 고딕</vt:lpstr>
      <vt:lpstr>Arial</vt:lpstr>
      <vt:lpstr>Calibri</vt:lpstr>
      <vt:lpstr>Calibri Light</vt:lpstr>
      <vt:lpstr>Symbol</vt:lpstr>
      <vt:lpstr>Office 테마</vt:lpstr>
      <vt:lpstr>Image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63</cp:revision>
  <dcterms:created xsi:type="dcterms:W3CDTF">2021-12-24T00:32:56Z</dcterms:created>
  <dcterms:modified xsi:type="dcterms:W3CDTF">2021-12-27T08:14:59Z</dcterms:modified>
</cp:coreProperties>
</file>